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8" r:id="rId2"/>
    <p:sldId id="296" r:id="rId3"/>
    <p:sldId id="297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06" autoAdjust="0"/>
    <p:restoredTop sz="94660"/>
  </p:normalViewPr>
  <p:slideViewPr>
    <p:cSldViewPr snapToGrid="0">
      <p:cViewPr varScale="1">
        <p:scale>
          <a:sx n="69" d="100"/>
          <a:sy n="69" d="100"/>
        </p:scale>
        <p:origin x="654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5FE65C7-683A-44DC-DDB3-B1C3FDB1AA0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40495B3D-D8CB-5B76-F77C-91DCACE1BE0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42FAE4B-E93C-0C18-6133-5715CA455A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2883E-E2C4-4ACC-8204-0E93C50C9348}" type="datetimeFigureOut">
              <a:rPr lang="zh-CN" altLang="en-US" smtClean="0"/>
              <a:t>2022/9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3B18A11-B73B-F640-D747-CD6326B41A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EF10D3C-F957-F2D3-AF4B-0DEBD39789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021A9-5DC5-4A1E-9E72-B33CED6342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69704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664E06C-0883-A4BF-7CD7-FBAB7897FE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24C1994-4FA6-7455-FECC-DF08BC20408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B73FEC1-7F26-C143-BDB3-70FF91DF90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2883E-E2C4-4ACC-8204-0E93C50C9348}" type="datetimeFigureOut">
              <a:rPr lang="zh-CN" altLang="en-US" smtClean="0"/>
              <a:t>2022/9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3B8788A-0B83-B61A-E89C-5873152F2B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17350D5-429E-1BFE-5A49-05FAF545CF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021A9-5DC5-4A1E-9E72-B33CED6342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75127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014CD7D-B456-6EFB-119C-CA43747E4D8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79459F3-47B8-A905-58D9-7A3FD0E7E21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FA78EA2-5FD3-E654-F208-4F28DFFBA6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2883E-E2C4-4ACC-8204-0E93C50C9348}" type="datetimeFigureOut">
              <a:rPr lang="zh-CN" altLang="en-US" smtClean="0"/>
              <a:t>2022/9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07BF514-2D31-57AA-486F-A4DC81387D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C9BEB94-67A1-C15F-0D2B-9C6E3AC3D4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021A9-5DC5-4A1E-9E72-B33CED6342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189706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A4A0CFC-3585-F8C1-7F09-AFC3B31F37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FF5BDB7-0E27-4C89-2BC3-AD3565E0D52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CBDF77E-1C2E-C5B4-68E2-53387C4421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2883E-E2C4-4ACC-8204-0E93C50C9348}" type="datetimeFigureOut">
              <a:rPr lang="zh-CN" altLang="en-US" smtClean="0"/>
              <a:t>2022/9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488D326-86DB-5FC0-07A8-49A9EEA1A1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FAD921A-7F0C-544A-5784-5DD496ACA6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021A9-5DC5-4A1E-9E72-B33CED6342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52284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EB0C914-7308-052D-582C-8CFD717B16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BA117A9-759E-4E2C-11D9-AE089E42AA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57394B9-92FF-5C8D-9AA4-C98EAE0BCD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2883E-E2C4-4ACC-8204-0E93C50C9348}" type="datetimeFigureOut">
              <a:rPr lang="zh-CN" altLang="en-US" smtClean="0"/>
              <a:t>2022/9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83E6B61-D82C-11F5-8AAC-28210C7646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B2BE228-BE88-0DDF-E471-C4BD561CFD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021A9-5DC5-4A1E-9E72-B33CED6342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80004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CAFD7E4-9925-6355-06F3-076C222B7A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1D364F2-9DCC-C556-CF3F-F8E94A21798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781BF90-FC24-7804-BAF0-0E864BBD319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A393344-F44E-AF0E-648E-5FBBF96A5B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2883E-E2C4-4ACC-8204-0E93C50C9348}" type="datetimeFigureOut">
              <a:rPr lang="zh-CN" altLang="en-US" smtClean="0"/>
              <a:t>2022/9/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6DF2DD1-8B55-E0B8-412E-053736D4A6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B89EB7A-9EE4-3E9F-B580-1E1B1F8F74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021A9-5DC5-4A1E-9E72-B33CED6342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94284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7A13579-53F0-9F49-03E7-71CAC7C0F3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E058D7E-9B9C-76EC-AFCA-8DE0CFD9E5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BD470C4-8169-05E6-332B-E3A3CE82168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C80C4437-1A2B-9031-08DD-C248C1D63D9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4A67E85A-DA28-9D45-4FDC-4F542924E51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4629038E-D5CA-B3AB-8CFF-C18116AC1C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2883E-E2C4-4ACC-8204-0E93C50C9348}" type="datetimeFigureOut">
              <a:rPr lang="zh-CN" altLang="en-US" smtClean="0"/>
              <a:t>2022/9/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BC675B8A-0979-1202-19A4-0F9016446F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3033C32A-B123-F082-085B-115F194CF3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021A9-5DC5-4A1E-9E72-B33CED6342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07951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601DFD7-DCAF-8849-A8C5-252E13976C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DFE79BE3-E0E7-826C-5840-2BE1D983AC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2883E-E2C4-4ACC-8204-0E93C50C9348}" type="datetimeFigureOut">
              <a:rPr lang="zh-CN" altLang="en-US" smtClean="0"/>
              <a:t>2022/9/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5E37878F-ED1E-C640-F5DE-5A6B6B8F04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9A024CCC-66B5-F822-609B-80B69AE1FD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021A9-5DC5-4A1E-9E72-B33CED6342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7131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061744CB-ED9A-0359-3431-D410561D9C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2883E-E2C4-4ACC-8204-0E93C50C9348}" type="datetimeFigureOut">
              <a:rPr lang="zh-CN" altLang="en-US" smtClean="0"/>
              <a:t>2022/9/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64BA9CF6-69BC-F84D-4173-0D4CE9BFEE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45C41FB-5A3D-5788-9F52-EAAF541370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021A9-5DC5-4A1E-9E72-B33CED6342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54732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BA64E60-3855-B8B0-BFEA-358D9B2705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B6F9378-9145-BDA1-C936-3249A89E504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C7BA551-981A-FE94-1A41-1AF6266359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4E2C419-7B43-26E0-64AF-A6107F3AF1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2883E-E2C4-4ACC-8204-0E93C50C9348}" type="datetimeFigureOut">
              <a:rPr lang="zh-CN" altLang="en-US" smtClean="0"/>
              <a:t>2022/9/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7B9A331-1AA3-4E07-8E74-325925B64B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018C431-B07D-E7B7-3DAA-FF2956FD70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021A9-5DC5-4A1E-9E72-B33CED6342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34927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D98C130-FC5D-235A-5DB1-DBC38D5898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08492EF8-1B56-6AE9-FC9F-639A2E1E629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AD0FEDE-B7F2-FA12-ACAB-F3D4845D6F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C3BB5D2-83EE-326F-8FDD-C6C0671363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2883E-E2C4-4ACC-8204-0E93C50C9348}" type="datetimeFigureOut">
              <a:rPr lang="zh-CN" altLang="en-US" smtClean="0"/>
              <a:t>2022/9/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900B196-DFD2-D941-7147-AEAA217443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38B7374-5DB2-34D1-9D7C-0E37E40806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021A9-5DC5-4A1E-9E72-B33CED6342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927745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7D10EF27-C013-7043-396D-846CCDE644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5304A52-4D60-B6DE-FDC6-4F2D2DBE76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1441E5D-CE99-6B3E-A69A-BDBEDD4D3A8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B2883E-E2C4-4ACC-8204-0E93C50C9348}" type="datetimeFigureOut">
              <a:rPr lang="zh-CN" altLang="en-US" smtClean="0"/>
              <a:t>2022/9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6184BE7-708E-4173-2D82-856F8DC9158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14F5C81-CB0D-E165-65E2-E31B7DE47EB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4021A9-5DC5-4A1E-9E72-B33CED6342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251013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tiff"/><Relationship Id="rId3" Type="http://schemas.openxmlformats.org/officeDocument/2006/relationships/image" Target="../media/image8.tiff"/><Relationship Id="rId7" Type="http://schemas.openxmlformats.org/officeDocument/2006/relationships/image" Target="../media/image12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tiff"/><Relationship Id="rId5" Type="http://schemas.openxmlformats.org/officeDocument/2006/relationships/image" Target="../media/image10.tiff"/><Relationship Id="rId10" Type="http://schemas.openxmlformats.org/officeDocument/2006/relationships/image" Target="../media/image15.tiff"/><Relationship Id="rId4" Type="http://schemas.openxmlformats.org/officeDocument/2006/relationships/image" Target="../media/image9.tiff"/><Relationship Id="rId9" Type="http://schemas.openxmlformats.org/officeDocument/2006/relationships/image" Target="../media/image14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png"/><Relationship Id="rId3" Type="http://schemas.openxmlformats.org/officeDocument/2006/relationships/image" Target="../media/image17.tiff"/><Relationship Id="rId7" Type="http://schemas.openxmlformats.org/officeDocument/2006/relationships/image" Target="../media/image21.tiff"/><Relationship Id="rId2" Type="http://schemas.openxmlformats.org/officeDocument/2006/relationships/image" Target="../media/image16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tiff"/><Relationship Id="rId5" Type="http://schemas.openxmlformats.org/officeDocument/2006/relationships/image" Target="../media/image19.tiff"/><Relationship Id="rId4" Type="http://schemas.openxmlformats.org/officeDocument/2006/relationships/image" Target="../media/image1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642255" y="81643"/>
            <a:ext cx="386987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The original data of western blotting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98378" y="832050"/>
            <a:ext cx="3466661" cy="2585721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5567" y="819795"/>
            <a:ext cx="3466660" cy="2585721"/>
          </a:xfrm>
          <a:prstGeom prst="rect">
            <a:avLst/>
          </a:prstGeom>
        </p:spPr>
      </p:pic>
      <p:sp>
        <p:nvSpPr>
          <p:cNvPr id="17" name="文本框 16"/>
          <p:cNvSpPr txBox="1"/>
          <p:nvPr/>
        </p:nvSpPr>
        <p:spPr>
          <a:xfrm rot="17647955">
            <a:off x="2546094" y="1160335"/>
            <a:ext cx="922949" cy="314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Control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 rot="17818482">
            <a:off x="2812089" y="1130228"/>
            <a:ext cx="952781" cy="3195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AngII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 rot="17938482">
            <a:off x="3111134" y="1157605"/>
            <a:ext cx="95377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+mn-cs"/>
                <a:sym typeface="+mn-ea"/>
              </a:rPr>
              <a:t>AngII+Qu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1916994" y="1738296"/>
            <a:ext cx="8926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lang="en-US" altLang="zh-CN" sz="1400" dirty="0">
                <a:solidFill>
                  <a:prstClr val="black"/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PCNA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3730461" y="1747501"/>
            <a:ext cx="8926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29kD</a:t>
            </a:r>
            <a:endParaRPr kumimoji="0" lang="zh-CN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23" name="矩形 22"/>
          <p:cNvSpPr/>
          <p:nvPr/>
        </p:nvSpPr>
        <p:spPr>
          <a:xfrm>
            <a:off x="2628897" y="1786807"/>
            <a:ext cx="1017921" cy="28633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endParaRPr kumimoji="0" lang="zh-CN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/>
              <a:ea typeface="微软雅黑" panose="020B0503020204020204" pitchFamily="34" charset="-122"/>
              <a:cs typeface="+mn-cs"/>
            </a:endParaRPr>
          </a:p>
        </p:txBody>
      </p:sp>
      <p:pic>
        <p:nvPicPr>
          <p:cNvPr id="10" name="图片 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67403" y="819795"/>
            <a:ext cx="3466661" cy="2585721"/>
          </a:xfrm>
          <a:prstGeom prst="rect">
            <a:avLst/>
          </a:prstGeom>
        </p:spPr>
      </p:pic>
      <p:sp>
        <p:nvSpPr>
          <p:cNvPr id="32" name="矩形 31"/>
          <p:cNvSpPr/>
          <p:nvPr/>
        </p:nvSpPr>
        <p:spPr>
          <a:xfrm>
            <a:off x="5885373" y="1528654"/>
            <a:ext cx="992061" cy="25815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4" name="矩形 33"/>
          <p:cNvSpPr/>
          <p:nvPr/>
        </p:nvSpPr>
        <p:spPr>
          <a:xfrm>
            <a:off x="9208690" y="2226403"/>
            <a:ext cx="992061" cy="25815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" name="文本框 1"/>
          <p:cNvSpPr txBox="1"/>
          <p:nvPr/>
        </p:nvSpPr>
        <p:spPr>
          <a:xfrm rot="17647955">
            <a:off x="5768084" y="886015"/>
            <a:ext cx="922949" cy="314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Control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 rot="17647955">
            <a:off x="9021824" y="1500695"/>
            <a:ext cx="922949" cy="314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Control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 rot="17818482">
            <a:off x="6042334" y="871783"/>
            <a:ext cx="952781" cy="3195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AngII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 rot="17818482">
            <a:off x="9368464" y="1486463"/>
            <a:ext cx="952781" cy="3195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AngII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 rot="17938482">
            <a:off x="6413134" y="922655"/>
            <a:ext cx="93726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+mn-cs"/>
                <a:sym typeface="+mn-ea"/>
              </a:rPr>
              <a:t>AngII+Qu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 rot="17938482">
            <a:off x="9742439" y="1504950"/>
            <a:ext cx="93789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+mn-cs"/>
                <a:sym typeface="+mn-ea"/>
              </a:rPr>
              <a:t>AngII+Qu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5175814" y="1479216"/>
            <a:ext cx="8926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lang="en-US" altLang="zh-CN" sz="1400" dirty="0">
                <a:solidFill>
                  <a:prstClr val="black"/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PCNA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8353059" y="2226310"/>
            <a:ext cx="79819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lang="en-US" altLang="zh-CN" sz="1400" dirty="0">
                <a:solidFill>
                  <a:prstClr val="black"/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PCNA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10523056" y="2226291"/>
            <a:ext cx="8926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29kD</a:t>
            </a:r>
            <a:endParaRPr kumimoji="0" lang="zh-CN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6930226" y="1488421"/>
            <a:ext cx="8926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29kD</a:t>
            </a:r>
            <a:endParaRPr kumimoji="0" lang="zh-CN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pic>
        <p:nvPicPr>
          <p:cNvPr id="47" name="图片 46">
            <a:extLst>
              <a:ext uri="{FF2B5EF4-FFF2-40B4-BE49-F238E27FC236}">
                <a16:creationId xmlns:a16="http://schemas.microsoft.com/office/drawing/2014/main" id="{AD353210-F576-4F14-E5CF-5959F2EBB376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06439" y="3874391"/>
            <a:ext cx="3481481" cy="2596775"/>
          </a:xfrm>
          <a:prstGeom prst="rect">
            <a:avLst/>
          </a:prstGeom>
        </p:spPr>
      </p:pic>
      <p:pic>
        <p:nvPicPr>
          <p:cNvPr id="48" name="图片 47">
            <a:extLst>
              <a:ext uri="{FF2B5EF4-FFF2-40B4-BE49-F238E27FC236}">
                <a16:creationId xmlns:a16="http://schemas.microsoft.com/office/drawing/2014/main" id="{912D852E-FFAD-D52C-AEBA-F74523111A5B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27369" y="3906231"/>
            <a:ext cx="3391312" cy="2529520"/>
          </a:xfrm>
          <a:prstGeom prst="rect">
            <a:avLst/>
          </a:prstGeom>
        </p:spPr>
      </p:pic>
      <p:pic>
        <p:nvPicPr>
          <p:cNvPr id="49" name="图片 48">
            <a:extLst>
              <a:ext uri="{FF2B5EF4-FFF2-40B4-BE49-F238E27FC236}">
                <a16:creationId xmlns:a16="http://schemas.microsoft.com/office/drawing/2014/main" id="{07649EA0-B6F9-38C2-6961-B873F28651F1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1762" y="3987094"/>
            <a:ext cx="3440489" cy="2566200"/>
          </a:xfrm>
          <a:prstGeom prst="rect">
            <a:avLst/>
          </a:prstGeom>
        </p:spPr>
      </p:pic>
      <p:sp>
        <p:nvSpPr>
          <p:cNvPr id="50" name="文本框 49">
            <a:extLst>
              <a:ext uri="{FF2B5EF4-FFF2-40B4-BE49-F238E27FC236}">
                <a16:creationId xmlns:a16="http://schemas.microsoft.com/office/drawing/2014/main" id="{271987A0-79C4-6395-67C3-A238A5567E50}"/>
              </a:ext>
            </a:extLst>
          </p:cNvPr>
          <p:cNvSpPr txBox="1"/>
          <p:nvPr/>
        </p:nvSpPr>
        <p:spPr>
          <a:xfrm>
            <a:off x="3374255" y="4977751"/>
            <a:ext cx="8926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37kD</a:t>
            </a:r>
            <a:endParaRPr kumimoji="0" lang="zh-CN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75936E3E-AE23-CAB3-4038-355492CF4878}"/>
              </a:ext>
            </a:extLst>
          </p:cNvPr>
          <p:cNvSpPr txBox="1"/>
          <p:nvPr/>
        </p:nvSpPr>
        <p:spPr>
          <a:xfrm>
            <a:off x="1280905" y="5017560"/>
            <a:ext cx="8926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GAPDH</a:t>
            </a:r>
            <a:endParaRPr kumimoji="0" lang="zh-CN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52" name="矩形 51">
            <a:extLst>
              <a:ext uri="{FF2B5EF4-FFF2-40B4-BE49-F238E27FC236}">
                <a16:creationId xmlns:a16="http://schemas.microsoft.com/office/drawing/2014/main" id="{F24F97E6-BD3E-2CBE-DDF0-76C3D590AF47}"/>
              </a:ext>
            </a:extLst>
          </p:cNvPr>
          <p:cNvSpPr/>
          <p:nvPr/>
        </p:nvSpPr>
        <p:spPr>
          <a:xfrm>
            <a:off x="2263090" y="5017756"/>
            <a:ext cx="992061" cy="25815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endParaRPr kumimoji="0" lang="zh-CN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/>
              <a:ea typeface="微软雅黑" panose="020B0503020204020204" pitchFamily="34" charset="-122"/>
              <a:cs typeface="+mn-cs"/>
            </a:endParaRPr>
          </a:p>
        </p:txBody>
      </p:sp>
      <p:sp>
        <p:nvSpPr>
          <p:cNvPr id="53" name="矩形 52">
            <a:extLst>
              <a:ext uri="{FF2B5EF4-FFF2-40B4-BE49-F238E27FC236}">
                <a16:creationId xmlns:a16="http://schemas.microsoft.com/office/drawing/2014/main" id="{76A903FF-29EA-3E6D-51AF-8F3B03BC8CC7}"/>
              </a:ext>
            </a:extLst>
          </p:cNvPr>
          <p:cNvSpPr/>
          <p:nvPr/>
        </p:nvSpPr>
        <p:spPr>
          <a:xfrm>
            <a:off x="5797563" y="5395484"/>
            <a:ext cx="975111" cy="26387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4" name="矩形 53">
            <a:extLst>
              <a:ext uri="{FF2B5EF4-FFF2-40B4-BE49-F238E27FC236}">
                <a16:creationId xmlns:a16="http://schemas.microsoft.com/office/drawing/2014/main" id="{105A4156-A88C-4D53-5536-79D8652C840B}"/>
              </a:ext>
            </a:extLst>
          </p:cNvPr>
          <p:cNvSpPr/>
          <p:nvPr/>
        </p:nvSpPr>
        <p:spPr>
          <a:xfrm>
            <a:off x="9317549" y="5097961"/>
            <a:ext cx="992061" cy="25815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EA4E37CB-F1E7-AA0D-BD70-4BADF282CC8E}"/>
              </a:ext>
            </a:extLst>
          </p:cNvPr>
          <p:cNvSpPr txBox="1"/>
          <p:nvPr/>
        </p:nvSpPr>
        <p:spPr>
          <a:xfrm rot="17827954">
            <a:off x="2145665" y="4328103"/>
            <a:ext cx="952781" cy="3195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Control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6FA1E8A3-42BE-3881-513F-16D55108D211}"/>
              </a:ext>
            </a:extLst>
          </p:cNvPr>
          <p:cNvSpPr txBox="1"/>
          <p:nvPr/>
        </p:nvSpPr>
        <p:spPr>
          <a:xfrm rot="18127955">
            <a:off x="5709285" y="4628458"/>
            <a:ext cx="952781" cy="3195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Control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65CEB39E-6583-417E-8F38-8A8DDBACA70C}"/>
              </a:ext>
            </a:extLst>
          </p:cNvPr>
          <p:cNvSpPr txBox="1"/>
          <p:nvPr/>
        </p:nvSpPr>
        <p:spPr>
          <a:xfrm rot="18127955">
            <a:off x="9265285" y="4319848"/>
            <a:ext cx="952781" cy="3195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Control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618C30EC-1B8B-9FA1-7B2F-FFBF715B51D4}"/>
              </a:ext>
            </a:extLst>
          </p:cNvPr>
          <p:cNvSpPr txBox="1"/>
          <p:nvPr/>
        </p:nvSpPr>
        <p:spPr>
          <a:xfrm rot="17878482">
            <a:off x="2473765" y="4313199"/>
            <a:ext cx="952781" cy="3195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AngII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AEECD2C1-AD7B-825B-A546-28F972F6028E}"/>
              </a:ext>
            </a:extLst>
          </p:cNvPr>
          <p:cNvSpPr txBox="1"/>
          <p:nvPr/>
        </p:nvSpPr>
        <p:spPr>
          <a:xfrm rot="18058482">
            <a:off x="6078660" y="4581169"/>
            <a:ext cx="952781" cy="3195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AngII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DBE2C6F0-1C2F-1461-3EB3-DA20011C0207}"/>
              </a:ext>
            </a:extLst>
          </p:cNvPr>
          <p:cNvSpPr txBox="1"/>
          <p:nvPr/>
        </p:nvSpPr>
        <p:spPr>
          <a:xfrm rot="18058482">
            <a:off x="9545760" y="4318914"/>
            <a:ext cx="952781" cy="3195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AngII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F4C7EC24-ADBD-8530-6E67-1533E0818452}"/>
              </a:ext>
            </a:extLst>
          </p:cNvPr>
          <p:cNvSpPr txBox="1"/>
          <p:nvPr/>
        </p:nvSpPr>
        <p:spPr>
          <a:xfrm rot="18058482">
            <a:off x="2692126" y="4307840"/>
            <a:ext cx="106616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+mn-cs"/>
                <a:sym typeface="+mn-ea"/>
              </a:rPr>
              <a:t>AngII+Qu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BBEDF501-A728-5224-6D0E-731F9AEDC21F}"/>
              </a:ext>
            </a:extLst>
          </p:cNvPr>
          <p:cNvSpPr txBox="1"/>
          <p:nvPr/>
        </p:nvSpPr>
        <p:spPr>
          <a:xfrm rot="17938482">
            <a:off x="6359251" y="4631055"/>
            <a:ext cx="94742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+mn-cs"/>
                <a:sym typeface="+mn-ea"/>
              </a:rPr>
              <a:t>AngII+Qu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87E4E5BB-DBCC-ED72-2CD4-95585D89BB75}"/>
              </a:ext>
            </a:extLst>
          </p:cNvPr>
          <p:cNvSpPr txBox="1"/>
          <p:nvPr/>
        </p:nvSpPr>
        <p:spPr>
          <a:xfrm rot="17938482">
            <a:off x="9731736" y="4291330"/>
            <a:ext cx="113919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+mn-cs"/>
                <a:sym typeface="+mn-ea"/>
              </a:rPr>
              <a:t>AngII+Qu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3B9D7C0A-EDFD-A0F1-67CD-18D3D1C816D8}"/>
              </a:ext>
            </a:extLst>
          </p:cNvPr>
          <p:cNvSpPr txBox="1"/>
          <p:nvPr/>
        </p:nvSpPr>
        <p:spPr>
          <a:xfrm>
            <a:off x="4831825" y="5316010"/>
            <a:ext cx="8926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GAPDH</a:t>
            </a:r>
            <a:endParaRPr kumimoji="0" lang="zh-CN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1EB484A6-F062-85AB-E402-D238C6508D29}"/>
              </a:ext>
            </a:extLst>
          </p:cNvPr>
          <p:cNvSpPr txBox="1"/>
          <p:nvPr/>
        </p:nvSpPr>
        <p:spPr>
          <a:xfrm>
            <a:off x="8460215" y="5056930"/>
            <a:ext cx="8926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GAPDH</a:t>
            </a:r>
            <a:endParaRPr kumimoji="0" lang="zh-CN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864A5A90-DED4-F560-0AF5-B69551C08F99}"/>
              </a:ext>
            </a:extLst>
          </p:cNvPr>
          <p:cNvSpPr txBox="1"/>
          <p:nvPr/>
        </p:nvSpPr>
        <p:spPr>
          <a:xfrm>
            <a:off x="6886440" y="5358116"/>
            <a:ext cx="8926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37kD</a:t>
            </a:r>
            <a:endParaRPr kumimoji="0" lang="zh-CN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EF0CA570-98B6-B4AD-0A0B-C60A4E3EEAA4}"/>
              </a:ext>
            </a:extLst>
          </p:cNvPr>
          <p:cNvSpPr txBox="1"/>
          <p:nvPr/>
        </p:nvSpPr>
        <p:spPr>
          <a:xfrm>
            <a:off x="10404340" y="5057761"/>
            <a:ext cx="8926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37kD</a:t>
            </a:r>
            <a:endParaRPr kumimoji="0" lang="zh-CN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395539" y="-2373"/>
            <a:ext cx="386987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original data of western blotting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7168" y="359089"/>
            <a:ext cx="2786020" cy="2078045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83474" y="281682"/>
            <a:ext cx="2693248" cy="2008846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28225" y="402973"/>
            <a:ext cx="2668394" cy="1990308"/>
          </a:xfrm>
          <a:prstGeom prst="rect">
            <a:avLst/>
          </a:prstGeom>
        </p:spPr>
      </p:pic>
      <p:sp>
        <p:nvSpPr>
          <p:cNvPr id="12" name="文本框 11"/>
          <p:cNvSpPr txBox="1"/>
          <p:nvPr/>
        </p:nvSpPr>
        <p:spPr>
          <a:xfrm>
            <a:off x="2022041" y="1114772"/>
            <a:ext cx="8926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JAK2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3858931" y="1084230"/>
            <a:ext cx="8926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5kD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矩形 13"/>
          <p:cNvSpPr/>
          <p:nvPr/>
        </p:nvSpPr>
        <p:spPr>
          <a:xfrm>
            <a:off x="2866583" y="1144598"/>
            <a:ext cx="992061" cy="25815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文本框 14"/>
          <p:cNvSpPr txBox="1"/>
          <p:nvPr/>
        </p:nvSpPr>
        <p:spPr>
          <a:xfrm rot="18007954">
            <a:off x="2836545" y="575310"/>
            <a:ext cx="83756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 rot="17998482">
            <a:off x="3055397" y="509171"/>
            <a:ext cx="9527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gII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 rot="18058482">
            <a:off x="3352165" y="627380"/>
            <a:ext cx="83883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AngII+Qu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" name="图片 1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16199" y="2487454"/>
            <a:ext cx="2667406" cy="1989571"/>
          </a:xfrm>
          <a:prstGeom prst="rect">
            <a:avLst/>
          </a:prstGeom>
        </p:spPr>
      </p:pic>
      <p:pic>
        <p:nvPicPr>
          <p:cNvPr id="22" name="图片 2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83317" y="2506938"/>
            <a:ext cx="2693246" cy="2008845"/>
          </a:xfrm>
          <a:prstGeom prst="rect">
            <a:avLst/>
          </a:prstGeom>
        </p:spPr>
      </p:pic>
      <p:pic>
        <p:nvPicPr>
          <p:cNvPr id="25" name="图片 24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4445" y="4610486"/>
            <a:ext cx="2712913" cy="2023514"/>
          </a:xfrm>
          <a:prstGeom prst="rect">
            <a:avLst/>
          </a:prstGeom>
        </p:spPr>
      </p:pic>
      <p:pic>
        <p:nvPicPr>
          <p:cNvPr id="27" name="图片 26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83405" y="4655613"/>
            <a:ext cx="2668393" cy="1990308"/>
          </a:xfrm>
          <a:prstGeom prst="rect">
            <a:avLst/>
          </a:prstGeom>
        </p:spPr>
      </p:pic>
      <p:pic>
        <p:nvPicPr>
          <p:cNvPr id="31" name="图片 30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7168" y="4689670"/>
            <a:ext cx="2668393" cy="1990307"/>
          </a:xfrm>
          <a:prstGeom prst="rect">
            <a:avLst/>
          </a:prstGeom>
        </p:spPr>
      </p:pic>
      <p:sp>
        <p:nvSpPr>
          <p:cNvPr id="34" name="文本框 33"/>
          <p:cNvSpPr txBox="1"/>
          <p:nvPr/>
        </p:nvSpPr>
        <p:spPr>
          <a:xfrm>
            <a:off x="1990031" y="3016010"/>
            <a:ext cx="8926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AK2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1844499" y="5784733"/>
            <a:ext cx="8926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矩形 35"/>
          <p:cNvSpPr/>
          <p:nvPr/>
        </p:nvSpPr>
        <p:spPr>
          <a:xfrm>
            <a:off x="5684022" y="816695"/>
            <a:ext cx="992061" cy="25815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8" name="矩形 37"/>
          <p:cNvSpPr/>
          <p:nvPr/>
        </p:nvSpPr>
        <p:spPr>
          <a:xfrm>
            <a:off x="2758885" y="3040823"/>
            <a:ext cx="992061" cy="25815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9" name="矩形 38"/>
          <p:cNvSpPr/>
          <p:nvPr/>
        </p:nvSpPr>
        <p:spPr>
          <a:xfrm>
            <a:off x="5696377" y="3169900"/>
            <a:ext cx="992061" cy="25815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0" name="矩形 39"/>
          <p:cNvSpPr/>
          <p:nvPr/>
        </p:nvSpPr>
        <p:spPr>
          <a:xfrm>
            <a:off x="2810155" y="5782465"/>
            <a:ext cx="992061" cy="25815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1" name="矩形 40"/>
          <p:cNvSpPr/>
          <p:nvPr/>
        </p:nvSpPr>
        <p:spPr>
          <a:xfrm>
            <a:off x="5611936" y="6014918"/>
            <a:ext cx="1073169" cy="26454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42" name="图片 41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82207" y="2487033"/>
            <a:ext cx="2859338" cy="2132730"/>
          </a:xfrm>
          <a:prstGeom prst="rect">
            <a:avLst/>
          </a:prstGeom>
        </p:spPr>
      </p:pic>
      <p:sp>
        <p:nvSpPr>
          <p:cNvPr id="44" name="矩形 43"/>
          <p:cNvSpPr/>
          <p:nvPr/>
        </p:nvSpPr>
        <p:spPr>
          <a:xfrm>
            <a:off x="8470361" y="1044462"/>
            <a:ext cx="992061" cy="25815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5" name="矩形 44"/>
          <p:cNvSpPr/>
          <p:nvPr/>
        </p:nvSpPr>
        <p:spPr>
          <a:xfrm>
            <a:off x="8669850" y="2754714"/>
            <a:ext cx="992061" cy="25815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6" name="矩形 45"/>
          <p:cNvSpPr/>
          <p:nvPr/>
        </p:nvSpPr>
        <p:spPr>
          <a:xfrm>
            <a:off x="8829866" y="5722727"/>
            <a:ext cx="992061" cy="25815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" name="文本框 3"/>
          <p:cNvSpPr txBox="1"/>
          <p:nvPr/>
        </p:nvSpPr>
        <p:spPr>
          <a:xfrm rot="18238482">
            <a:off x="3221990" y="2372995"/>
            <a:ext cx="89471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AngII+Qu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 rot="18187954">
            <a:off x="5619349" y="264839"/>
            <a:ext cx="9527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 rot="18187954">
            <a:off x="8454624" y="364534"/>
            <a:ext cx="9527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 rot="18187954">
            <a:off x="2782804" y="2399074"/>
            <a:ext cx="9527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 rot="18187954">
            <a:off x="5703804" y="2466384"/>
            <a:ext cx="9527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 rot="18187954">
            <a:off x="8608929" y="1984419"/>
            <a:ext cx="9527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 rot="18187954">
            <a:off x="2886309" y="5069884"/>
            <a:ext cx="9527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 rot="18187954">
            <a:off x="5678805" y="5318125"/>
            <a:ext cx="83312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 rot="18187954">
            <a:off x="8850229" y="5008924"/>
            <a:ext cx="9527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 rot="18178482">
            <a:off x="5873527" y="203101"/>
            <a:ext cx="9527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gII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 rot="18178482">
            <a:off x="8674512" y="364391"/>
            <a:ext cx="9527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gII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 rot="18178482">
            <a:off x="3006502" y="2345591"/>
            <a:ext cx="9527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gII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 rot="18178482">
            <a:off x="5931312" y="2466876"/>
            <a:ext cx="9527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gII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 rot="18178482">
            <a:off x="8849137" y="1984276"/>
            <a:ext cx="9527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gII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 rot="18178482">
            <a:off x="3123977" y="5070376"/>
            <a:ext cx="9527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gII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 rot="18178482">
            <a:off x="5872892" y="5239286"/>
            <a:ext cx="9527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gII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文本框 46"/>
          <p:cNvSpPr txBox="1"/>
          <p:nvPr/>
        </p:nvSpPr>
        <p:spPr>
          <a:xfrm rot="18178482">
            <a:off x="9088532" y="5008781"/>
            <a:ext cx="9527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gII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/>
          <p:cNvSpPr txBox="1"/>
          <p:nvPr/>
        </p:nvSpPr>
        <p:spPr>
          <a:xfrm rot="18238482">
            <a:off x="3362325" y="5149850"/>
            <a:ext cx="86106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AngII+Qu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48"/>
          <p:cNvSpPr txBox="1"/>
          <p:nvPr/>
        </p:nvSpPr>
        <p:spPr>
          <a:xfrm rot="18238482">
            <a:off x="6130925" y="5323840"/>
            <a:ext cx="82105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AngII+Qu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/>
          <p:cNvSpPr txBox="1"/>
          <p:nvPr/>
        </p:nvSpPr>
        <p:spPr>
          <a:xfrm rot="18238482">
            <a:off x="9281160" y="4914265"/>
            <a:ext cx="118681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AngII+Qu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/>
          <p:cNvSpPr txBox="1"/>
          <p:nvPr/>
        </p:nvSpPr>
        <p:spPr>
          <a:xfrm>
            <a:off x="4966536" y="836007"/>
            <a:ext cx="8926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JAK2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文本框 51"/>
          <p:cNvSpPr txBox="1"/>
          <p:nvPr/>
        </p:nvSpPr>
        <p:spPr>
          <a:xfrm>
            <a:off x="7777046" y="1019522"/>
            <a:ext cx="8926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JAK2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/>
          <p:cNvSpPr txBox="1"/>
          <p:nvPr/>
        </p:nvSpPr>
        <p:spPr>
          <a:xfrm>
            <a:off x="9648861" y="978185"/>
            <a:ext cx="8926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5kD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文本框 53"/>
          <p:cNvSpPr txBox="1"/>
          <p:nvPr/>
        </p:nvSpPr>
        <p:spPr>
          <a:xfrm>
            <a:off x="6789456" y="745775"/>
            <a:ext cx="8926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5kD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文本框 54"/>
          <p:cNvSpPr txBox="1"/>
          <p:nvPr/>
        </p:nvSpPr>
        <p:spPr>
          <a:xfrm>
            <a:off x="3858931" y="3016535"/>
            <a:ext cx="892629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文本框 55"/>
          <p:cNvSpPr txBox="1"/>
          <p:nvPr/>
        </p:nvSpPr>
        <p:spPr>
          <a:xfrm>
            <a:off x="9780306" y="2743485"/>
            <a:ext cx="892629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本框 56"/>
          <p:cNvSpPr txBox="1"/>
          <p:nvPr/>
        </p:nvSpPr>
        <p:spPr>
          <a:xfrm>
            <a:off x="6934835" y="3130550"/>
            <a:ext cx="97536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文本框 57"/>
          <p:cNvSpPr txBox="1"/>
          <p:nvPr/>
        </p:nvSpPr>
        <p:spPr>
          <a:xfrm>
            <a:off x="7936806" y="2704860"/>
            <a:ext cx="8926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AK2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文本框 58"/>
          <p:cNvSpPr txBox="1"/>
          <p:nvPr/>
        </p:nvSpPr>
        <p:spPr>
          <a:xfrm>
            <a:off x="5081211" y="3142375"/>
            <a:ext cx="8926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AK2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文本框 60"/>
          <p:cNvSpPr txBox="1"/>
          <p:nvPr/>
        </p:nvSpPr>
        <p:spPr>
          <a:xfrm>
            <a:off x="7937050" y="5697962"/>
            <a:ext cx="8926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文本框 61"/>
          <p:cNvSpPr txBox="1"/>
          <p:nvPr/>
        </p:nvSpPr>
        <p:spPr>
          <a:xfrm>
            <a:off x="4826820" y="5981172"/>
            <a:ext cx="8926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文本框 62"/>
          <p:cNvSpPr txBox="1"/>
          <p:nvPr/>
        </p:nvSpPr>
        <p:spPr>
          <a:xfrm>
            <a:off x="3890046" y="5782595"/>
            <a:ext cx="892629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kD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文本框 63"/>
          <p:cNvSpPr txBox="1"/>
          <p:nvPr/>
        </p:nvSpPr>
        <p:spPr>
          <a:xfrm>
            <a:off x="6789456" y="5981350"/>
            <a:ext cx="892629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kD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文本框 64"/>
          <p:cNvSpPr txBox="1"/>
          <p:nvPr/>
        </p:nvSpPr>
        <p:spPr>
          <a:xfrm>
            <a:off x="9940326" y="5698140"/>
            <a:ext cx="892629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kD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文本框 65"/>
          <p:cNvSpPr txBox="1"/>
          <p:nvPr/>
        </p:nvSpPr>
        <p:spPr>
          <a:xfrm rot="18238482">
            <a:off x="6158865" y="2544445"/>
            <a:ext cx="92392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AngII+Qu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文本框 66"/>
          <p:cNvSpPr txBox="1"/>
          <p:nvPr/>
        </p:nvSpPr>
        <p:spPr>
          <a:xfrm rot="18238482">
            <a:off x="9097645" y="2055495"/>
            <a:ext cx="93916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AngII+Qu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 rot="18058482">
            <a:off x="6111875" y="365760"/>
            <a:ext cx="83883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AngII+Qu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 rot="18058482">
            <a:off x="8949055" y="476250"/>
            <a:ext cx="83883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AngII+Qu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1008489" y="157715"/>
            <a:ext cx="386987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The original data of western blotting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1625" y="498606"/>
            <a:ext cx="2658724" cy="1983095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57987" y="498606"/>
            <a:ext cx="2658725" cy="1983096"/>
          </a:xfrm>
          <a:prstGeom prst="rect">
            <a:avLst/>
          </a:prstGeom>
        </p:spPr>
      </p:pic>
      <p:pic>
        <p:nvPicPr>
          <p:cNvPr id="24" name="图片 2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30999" y="2641545"/>
            <a:ext cx="2658724" cy="1983095"/>
          </a:xfrm>
          <a:prstGeom prst="rect">
            <a:avLst/>
          </a:prstGeom>
        </p:spPr>
      </p:pic>
      <p:pic>
        <p:nvPicPr>
          <p:cNvPr id="26" name="图片 2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57987" y="2686761"/>
            <a:ext cx="2658723" cy="1983095"/>
          </a:xfrm>
          <a:prstGeom prst="rect">
            <a:avLst/>
          </a:prstGeom>
        </p:spPr>
      </p:pic>
      <p:pic>
        <p:nvPicPr>
          <p:cNvPr id="28" name="图片 2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6149" y="4817015"/>
            <a:ext cx="2683574" cy="2001629"/>
          </a:xfrm>
          <a:prstGeom prst="rect">
            <a:avLst/>
          </a:prstGeom>
        </p:spPr>
      </p:pic>
      <p:pic>
        <p:nvPicPr>
          <p:cNvPr id="31" name="图片 30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57987" y="4835549"/>
            <a:ext cx="2658724" cy="1983096"/>
          </a:xfrm>
          <a:prstGeom prst="rect">
            <a:avLst/>
          </a:prstGeom>
        </p:spPr>
      </p:pic>
      <p:sp>
        <p:nvSpPr>
          <p:cNvPr id="32" name="文本框 31"/>
          <p:cNvSpPr txBox="1"/>
          <p:nvPr/>
        </p:nvSpPr>
        <p:spPr>
          <a:xfrm rot="17938482">
            <a:off x="3627120" y="1022350"/>
            <a:ext cx="86931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+mn-cs"/>
                <a:sym typeface="+mn-ea"/>
              </a:rPr>
              <a:t>AngII+Qu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 rot="17758482">
            <a:off x="4548505" y="937260"/>
            <a:ext cx="85915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+mn-cs"/>
                <a:sym typeface="+mn-ea"/>
              </a:rPr>
              <a:t>AngII+Qu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34" name="文本框 33"/>
          <p:cNvSpPr txBox="1"/>
          <p:nvPr/>
        </p:nvSpPr>
        <p:spPr>
          <a:xfrm rot="17938482">
            <a:off x="4283251" y="947905"/>
            <a:ext cx="915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AngII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35" name="文本框 34"/>
          <p:cNvSpPr txBox="1"/>
          <p:nvPr/>
        </p:nvSpPr>
        <p:spPr>
          <a:xfrm rot="17878482">
            <a:off x="3331595" y="969659"/>
            <a:ext cx="9603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AngII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36" name="文本框 35"/>
          <p:cNvSpPr txBox="1"/>
          <p:nvPr/>
        </p:nvSpPr>
        <p:spPr>
          <a:xfrm rot="18007955">
            <a:off x="3103055" y="976906"/>
            <a:ext cx="9527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Control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 rot="17827954">
            <a:off x="4061666" y="967842"/>
            <a:ext cx="952781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Control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2439522" y="1460744"/>
            <a:ext cx="11241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p-STAT3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5007610" y="1468120"/>
            <a:ext cx="73469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79kD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86kD</a:t>
            </a:r>
          </a:p>
        </p:txBody>
      </p:sp>
      <p:sp>
        <p:nvSpPr>
          <p:cNvPr id="40" name="文本框 39"/>
          <p:cNvSpPr txBox="1"/>
          <p:nvPr/>
        </p:nvSpPr>
        <p:spPr>
          <a:xfrm>
            <a:off x="2606896" y="3622486"/>
            <a:ext cx="8926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STAT3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2670783" y="5383883"/>
            <a:ext cx="8926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GAPDH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42" name="矩形 41"/>
          <p:cNvSpPr/>
          <p:nvPr/>
        </p:nvSpPr>
        <p:spPr>
          <a:xfrm>
            <a:off x="3220602" y="1538146"/>
            <a:ext cx="880483" cy="28946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endParaRPr kumimoji="0" lang="zh-CN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/>
              <a:ea typeface="微软雅黑" panose="020B0503020204020204" pitchFamily="34" charset="-122"/>
              <a:cs typeface="+mn-cs"/>
            </a:endParaRPr>
          </a:p>
        </p:txBody>
      </p:sp>
      <p:sp>
        <p:nvSpPr>
          <p:cNvPr id="43" name="矩形 42"/>
          <p:cNvSpPr/>
          <p:nvPr/>
        </p:nvSpPr>
        <p:spPr>
          <a:xfrm>
            <a:off x="4159180" y="1542124"/>
            <a:ext cx="863836" cy="2901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endParaRPr kumimoji="0" lang="zh-CN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/>
              <a:ea typeface="微软雅黑" panose="020B0503020204020204" pitchFamily="34" charset="-122"/>
              <a:cs typeface="+mn-cs"/>
            </a:endParaRPr>
          </a:p>
        </p:txBody>
      </p:sp>
      <p:sp>
        <p:nvSpPr>
          <p:cNvPr id="44" name="矩形 43"/>
          <p:cNvSpPr/>
          <p:nvPr/>
        </p:nvSpPr>
        <p:spPr>
          <a:xfrm>
            <a:off x="7340054" y="1469548"/>
            <a:ext cx="992061" cy="30777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endParaRPr kumimoji="0" lang="zh-CN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/>
              <a:ea typeface="微软雅黑" panose="020B0503020204020204" pitchFamily="34" charset="-122"/>
              <a:cs typeface="+mn-cs"/>
            </a:endParaRPr>
          </a:p>
        </p:txBody>
      </p:sp>
      <p:pic>
        <p:nvPicPr>
          <p:cNvPr id="45" name="图片 44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271143" y="3603464"/>
            <a:ext cx="1005927" cy="323116"/>
          </a:xfrm>
          <a:prstGeom prst="rect">
            <a:avLst/>
          </a:prstGeom>
        </p:spPr>
      </p:pic>
      <p:sp>
        <p:nvSpPr>
          <p:cNvPr id="46" name="矩形 45"/>
          <p:cNvSpPr/>
          <p:nvPr/>
        </p:nvSpPr>
        <p:spPr>
          <a:xfrm>
            <a:off x="4308943" y="3611134"/>
            <a:ext cx="992061" cy="30777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endParaRPr kumimoji="0" lang="zh-CN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/>
              <a:ea typeface="微软雅黑" panose="020B0503020204020204" pitchFamily="34" charset="-122"/>
              <a:cs typeface="+mn-cs"/>
            </a:endParaRPr>
          </a:p>
        </p:txBody>
      </p:sp>
      <p:sp>
        <p:nvSpPr>
          <p:cNvPr id="47" name="矩形 46"/>
          <p:cNvSpPr/>
          <p:nvPr/>
        </p:nvSpPr>
        <p:spPr>
          <a:xfrm>
            <a:off x="7340053" y="3603464"/>
            <a:ext cx="992061" cy="30777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endParaRPr kumimoji="0" lang="zh-CN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/>
              <a:ea typeface="微软雅黑" panose="020B0503020204020204" pitchFamily="34" charset="-122"/>
              <a:cs typeface="+mn-cs"/>
            </a:endParaRPr>
          </a:p>
        </p:txBody>
      </p:sp>
      <p:sp>
        <p:nvSpPr>
          <p:cNvPr id="48" name="矩形 47"/>
          <p:cNvSpPr/>
          <p:nvPr/>
        </p:nvSpPr>
        <p:spPr>
          <a:xfrm>
            <a:off x="3499407" y="5385507"/>
            <a:ext cx="992061" cy="30777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endParaRPr kumimoji="0" lang="zh-CN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/>
              <a:ea typeface="微软雅黑" panose="020B0503020204020204" pitchFamily="34" charset="-122"/>
              <a:cs typeface="+mn-cs"/>
            </a:endParaRPr>
          </a:p>
        </p:txBody>
      </p:sp>
      <p:sp>
        <p:nvSpPr>
          <p:cNvPr id="49" name="矩形 48"/>
          <p:cNvSpPr/>
          <p:nvPr/>
        </p:nvSpPr>
        <p:spPr>
          <a:xfrm>
            <a:off x="4535181" y="5385507"/>
            <a:ext cx="992061" cy="30777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endParaRPr kumimoji="0" lang="zh-CN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/>
              <a:ea typeface="微软雅黑" panose="020B0503020204020204" pitchFamily="34" charset="-122"/>
              <a:cs typeface="+mn-cs"/>
            </a:endParaRPr>
          </a:p>
        </p:txBody>
      </p:sp>
      <p:sp>
        <p:nvSpPr>
          <p:cNvPr id="50" name="矩形 49"/>
          <p:cNvSpPr/>
          <p:nvPr/>
        </p:nvSpPr>
        <p:spPr>
          <a:xfrm>
            <a:off x="7024368" y="5318837"/>
            <a:ext cx="992061" cy="30777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endParaRPr kumimoji="0" lang="zh-CN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/>
              <a:ea typeface="微软雅黑" panose="020B0503020204020204" pitchFamily="34" charset="-122"/>
              <a:cs typeface="+mn-cs"/>
            </a:endParaRPr>
          </a:p>
        </p:txBody>
      </p:sp>
      <p:sp>
        <p:nvSpPr>
          <p:cNvPr id="2" name="文本框 1"/>
          <p:cNvSpPr txBox="1"/>
          <p:nvPr/>
        </p:nvSpPr>
        <p:spPr>
          <a:xfrm rot="17827955">
            <a:off x="4186992" y="2946856"/>
            <a:ext cx="952781" cy="3195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Control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 rot="17827955">
            <a:off x="7311192" y="881201"/>
            <a:ext cx="952781" cy="3195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Control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4" name="文本框 3"/>
          <p:cNvSpPr txBox="1"/>
          <p:nvPr/>
        </p:nvSpPr>
        <p:spPr>
          <a:xfrm rot="17827955">
            <a:off x="3264972" y="2946856"/>
            <a:ext cx="952781" cy="3195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Control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 rot="17827955">
            <a:off x="7276267" y="2945586"/>
            <a:ext cx="952781" cy="3195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Control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 rot="17827955">
            <a:off x="3518972" y="4782006"/>
            <a:ext cx="952781" cy="3195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Control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 rot="17827955">
            <a:off x="7007027" y="4669611"/>
            <a:ext cx="952781" cy="3195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Control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 rot="17827955">
            <a:off x="4467860" y="4735195"/>
            <a:ext cx="95631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Control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 rot="17878482">
            <a:off x="3513796" y="2952675"/>
            <a:ext cx="960386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AngII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 rot="17878482">
            <a:off x="4415496" y="2983790"/>
            <a:ext cx="960386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AngII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 rot="17878482">
            <a:off x="7490801" y="2962200"/>
            <a:ext cx="960386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AngII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 rot="17878482">
            <a:off x="3760811" y="4751630"/>
            <a:ext cx="960386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AngII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 rot="17878482">
            <a:off x="4686006" y="4735120"/>
            <a:ext cx="960386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AngII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 rot="17878482">
            <a:off x="7220291" y="4677335"/>
            <a:ext cx="960386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AngII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 rot="17998482">
            <a:off x="3707765" y="2969895"/>
            <a:ext cx="110934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+mn-cs"/>
                <a:sym typeface="+mn-ea"/>
              </a:rPr>
              <a:t>AngII+Qu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 rot="17998482">
            <a:off x="4645660" y="2919730"/>
            <a:ext cx="97663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+mn-cs"/>
                <a:sym typeface="+mn-ea"/>
              </a:rPr>
              <a:t>AngII+Qu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 rot="17998482">
            <a:off x="7737475" y="2959735"/>
            <a:ext cx="95504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+mn-cs"/>
                <a:sym typeface="+mn-ea"/>
              </a:rPr>
              <a:t>AngII+Qu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 rot="17998482">
            <a:off x="3987800" y="4782820"/>
            <a:ext cx="98361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+mn-cs"/>
                <a:sym typeface="+mn-ea"/>
              </a:rPr>
              <a:t>AngII+Qu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 rot="17998482">
            <a:off x="4973955" y="4749800"/>
            <a:ext cx="97155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+mn-cs"/>
                <a:sym typeface="+mn-ea"/>
              </a:rPr>
              <a:t>AngII+Qu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 rot="17998482">
            <a:off x="7463155" y="4649470"/>
            <a:ext cx="103187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+mn-cs"/>
                <a:sym typeface="+mn-ea"/>
              </a:rPr>
              <a:t>AngII+Qu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6388735" y="1461770"/>
            <a:ext cx="95123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p-STAT3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51" name="文本框 50"/>
          <p:cNvSpPr txBox="1"/>
          <p:nvPr/>
        </p:nvSpPr>
        <p:spPr>
          <a:xfrm>
            <a:off x="8331835" y="1454150"/>
            <a:ext cx="58610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79kD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86kD</a:t>
            </a:r>
          </a:p>
        </p:txBody>
      </p:sp>
      <p:sp>
        <p:nvSpPr>
          <p:cNvPr id="52" name="文本框 51"/>
          <p:cNvSpPr txBox="1"/>
          <p:nvPr/>
        </p:nvSpPr>
        <p:spPr>
          <a:xfrm>
            <a:off x="5392585" y="3580474"/>
            <a:ext cx="1178164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88kD</a:t>
            </a:r>
            <a:endParaRPr kumimoji="0" lang="zh-CN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53" name="文本框 52"/>
          <p:cNvSpPr txBox="1"/>
          <p:nvPr/>
        </p:nvSpPr>
        <p:spPr>
          <a:xfrm>
            <a:off x="8462175" y="3588094"/>
            <a:ext cx="1178164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88kD</a:t>
            </a:r>
            <a:endParaRPr kumimoji="0" lang="zh-CN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54" name="文本框 53"/>
          <p:cNvSpPr txBox="1"/>
          <p:nvPr/>
        </p:nvSpPr>
        <p:spPr>
          <a:xfrm>
            <a:off x="5590070" y="5369269"/>
            <a:ext cx="1178164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37D</a:t>
            </a:r>
            <a:endParaRPr kumimoji="0" lang="zh-CN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55" name="文本框 54"/>
          <p:cNvSpPr txBox="1"/>
          <p:nvPr/>
        </p:nvSpPr>
        <p:spPr>
          <a:xfrm>
            <a:off x="8182775" y="5326724"/>
            <a:ext cx="1178164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37kD</a:t>
            </a:r>
            <a:endParaRPr kumimoji="0" lang="zh-CN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56" name="文本框 55"/>
          <p:cNvSpPr txBox="1"/>
          <p:nvPr/>
        </p:nvSpPr>
        <p:spPr>
          <a:xfrm>
            <a:off x="6571201" y="3580576"/>
            <a:ext cx="8926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STAT3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57" name="文本框 56"/>
          <p:cNvSpPr txBox="1"/>
          <p:nvPr/>
        </p:nvSpPr>
        <p:spPr>
          <a:xfrm>
            <a:off x="6273773" y="5318478"/>
            <a:ext cx="8926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GAPDH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58" name="文本框 57"/>
          <p:cNvSpPr txBox="1"/>
          <p:nvPr/>
        </p:nvSpPr>
        <p:spPr>
          <a:xfrm rot="17878482">
            <a:off x="7525726" y="869875"/>
            <a:ext cx="960386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AngII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59" name="文本框 58"/>
          <p:cNvSpPr txBox="1"/>
          <p:nvPr/>
        </p:nvSpPr>
        <p:spPr>
          <a:xfrm rot="17998482">
            <a:off x="7740015" y="879475"/>
            <a:ext cx="94551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+mn-cs"/>
                <a:sym typeface="+mn-ea"/>
              </a:rPr>
              <a:t>AngII+Qu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7</TotalTime>
  <Words>182</Words>
  <Application>Microsoft Office PowerPoint</Application>
  <PresentationFormat>Widescreen</PresentationFormat>
  <Paragraphs>119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等线</vt:lpstr>
      <vt:lpstr>等线 Light</vt:lpstr>
      <vt:lpstr>Arial</vt:lpstr>
      <vt:lpstr>Times New Roman</vt:lpstr>
      <vt:lpstr>Office 主题​​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迪</dc:creator>
  <cp:lastModifiedBy>Administrator</cp:lastModifiedBy>
  <cp:revision>9</cp:revision>
  <dcterms:created xsi:type="dcterms:W3CDTF">2022-05-23T15:32:56Z</dcterms:created>
  <dcterms:modified xsi:type="dcterms:W3CDTF">2022-09-09T01:52:22Z</dcterms:modified>
</cp:coreProperties>
</file>